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56" r:id="rId3"/>
    <p:sldId id="258" r:id="rId4"/>
    <p:sldId id="260" r:id="rId5"/>
  </p:sldIdLst>
  <p:sldSz cx="7559675" cy="104394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97" d="100"/>
          <a:sy n="97" d="100"/>
        </p:scale>
        <p:origin x="3510" y="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449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6637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2657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3033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1265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0024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991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2166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1890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6749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7825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160BB-E1B4-4190-9881-0F168905F39E}" type="datetimeFigureOut">
              <a:rPr lang="fr-FR" smtClean="0"/>
              <a:t>11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C2A9B-E83E-4EDE-8CED-58A30F964E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5093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3838362"/>
              </p:ext>
            </p:extLst>
          </p:nvPr>
        </p:nvGraphicFramePr>
        <p:xfrm>
          <a:off x="330199" y="659399"/>
          <a:ext cx="6692900" cy="584860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21860">
                  <a:extLst>
                    <a:ext uri="{9D8B030D-6E8A-4147-A177-3AD203B41FA5}">
                      <a16:colId xmlns:a16="http://schemas.microsoft.com/office/drawing/2014/main" val="487701305"/>
                    </a:ext>
                  </a:extLst>
                </a:gridCol>
                <a:gridCol w="4196265">
                  <a:extLst>
                    <a:ext uri="{9D8B030D-6E8A-4147-A177-3AD203B41FA5}">
                      <a16:colId xmlns:a16="http://schemas.microsoft.com/office/drawing/2014/main" val="1702440836"/>
                    </a:ext>
                  </a:extLst>
                </a:gridCol>
                <a:gridCol w="1474775">
                  <a:extLst>
                    <a:ext uri="{9D8B030D-6E8A-4147-A177-3AD203B41FA5}">
                      <a16:colId xmlns:a16="http://schemas.microsoft.com/office/drawing/2014/main" val="1971046996"/>
                    </a:ext>
                  </a:extLst>
                </a:gridCol>
              </a:tblGrid>
              <a:tr h="213348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Name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5' to 3' sequence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Restriction site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695437"/>
                  </a:ext>
                </a:extLst>
              </a:tr>
              <a:tr h="187021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5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GCGGATCCATGAAATGGCGTCGTGTAC 		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BamH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5967720"/>
                  </a:ext>
                </a:extLst>
              </a:tr>
              <a:tr h="209462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GGGGTACCCTAAAAACTTTTGAAACATGG 	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Kpn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9434376"/>
                  </a:ext>
                </a:extLst>
              </a:tr>
              <a:tr h="209462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GCGGATCCGTGCTGATTGGAAAACGC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BamH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3532333"/>
                  </a:ext>
                </a:extLst>
              </a:tr>
              <a:tr h="187021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CGGGGTACCTTATTGAGTTGGATATGGTAC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effectLst/>
                        </a:rPr>
                        <a:t>KpnI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2819044"/>
                  </a:ext>
                </a:extLst>
              </a:tr>
              <a:tr h="209462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31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CGCGGATCCATGGAATTATTAGC	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BamH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8802763"/>
                  </a:ext>
                </a:extLst>
              </a:tr>
              <a:tr h="187021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3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CGGGGTACCTTAGTTTGTTTTTAATTTAGC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Kpn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6841386"/>
                  </a:ext>
                </a:extLst>
              </a:tr>
              <a:tr h="142136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45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ATTTACGATTACAGCGCGAGTAATTCCTACGCGATC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8372913"/>
                  </a:ext>
                </a:extLst>
              </a:tr>
              <a:tr h="142136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4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GGAATTACTCGCGCTGTAATCGTAAATGCACTACGT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3866196"/>
                  </a:ext>
                </a:extLst>
              </a:tr>
              <a:tr h="142136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4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ATTTACGATTACATCGCGAGTAATTCCTACGCGATC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5112772"/>
                  </a:ext>
                </a:extLst>
              </a:tr>
              <a:tr h="142136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4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GGAATTACTCGCGATGTAATCGTAAATGCACTACGT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4800094"/>
                  </a:ext>
                </a:extLst>
              </a:tr>
              <a:tr h="142136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10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GGGGTACCTTTTGGAGGCGCTC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Kpn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2160268"/>
                  </a:ext>
                </a:extLst>
              </a:tr>
              <a:tr h="142136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109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GCGGATCCGGATCGCGTCTGCC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solidFill>
                            <a:schemeClr val="tx1"/>
                          </a:solidFill>
                          <a:effectLst/>
                        </a:rPr>
                        <a:t>BamHI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9342188"/>
                  </a:ext>
                </a:extLst>
              </a:tr>
              <a:tr h="183281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201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GACACGATATATACCAAGG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5728976"/>
                  </a:ext>
                </a:extLst>
              </a:tr>
              <a:tr h="183281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20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ACTCTTGCGTACGCATGC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5849205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SAT203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TTTAACAATTACGCTGGAAAGCCAATATAAAAAAATGGGG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3201938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204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ATATTGCTTTCCAGCGTAATTGTTAAACGTAAATATGC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1060403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SAT205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AAACTGCAGGTCTCCTTCGCAGGTTCAC 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Pst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2366644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20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CGCGGATCCACTCTTGCGTACGCATGC 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BamH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2869800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SAT207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</a:rPr>
                        <a:t>AAACTGCAGCATCCCTTATTTCCTCCCC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Pst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1548685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20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GCGGATCCCCATTCTTGATCCAGTGCGTC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BamH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9805913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AT209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AAACTGCAGGAAAGCGGAGTAACTGC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PstI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2855694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AT210</a:t>
                      </a: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GCGGATCCCTGATGCAACTCCCATACC</a:t>
                      </a: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mHI</a:t>
                      </a:r>
                      <a:endParaRPr lang="en-US" sz="1400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200279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AT220</a:t>
                      </a: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AACTGCAGGCTCTTTAGGTATGAAAGG</a:t>
                      </a:r>
                      <a:endParaRPr lang="en-US" sz="1400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stI</a:t>
                      </a:r>
                      <a:endParaRPr lang="en-US" sz="1400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7965353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AT221</a:t>
                      </a: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GCGGATCCAGTCCGAAATGAACACCAGC</a:t>
                      </a:r>
                      <a:endParaRPr lang="en-US" sz="1400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mHI</a:t>
                      </a:r>
                      <a:endParaRPr lang="en-US" sz="1400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37686" marR="37686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64156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</a:rPr>
                        <a:t>VcodYBc1</a:t>
                      </a: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GTGAAAGTTCAAGATAAAGC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5083092"/>
                  </a:ext>
                </a:extLst>
              </a:tr>
              <a:tr h="220684"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VcodyBc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017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TTCAAGGATCGCGTCTGCC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9017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9599782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-1814616" y="2780699"/>
            <a:ext cx="15526477" cy="4453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6" name="ZoneTexte 5"/>
          <p:cNvSpPr txBox="1"/>
          <p:nvPr/>
        </p:nvSpPr>
        <p:spPr>
          <a:xfrm>
            <a:off x="330199" y="355600"/>
            <a:ext cx="3741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le S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igonucleotid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01206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73206" y="292732"/>
            <a:ext cx="16834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-62753" y="7437989"/>
            <a:ext cx="7485529" cy="33932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-457200"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 Mutation of S215 does not alter the overall structure of </a:t>
            </a:r>
            <a:r>
              <a:rPr lang="en-US" sz="11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dY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Purified proteins used in this study were separated on a 12,5% SDS-PAGE gel and stained with </a:t>
            </a:r>
            <a:r>
              <a:rPr lang="en-US" sz="11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omassie</a:t>
            </a:r>
            <a:r>
              <a:rPr lang="en-US" sz="11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B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 spectra of His-tagged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dY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lue), CodY-S215A (green) and S215D (purple).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)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l filtration of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dY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its mutant versions.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)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column was equilibrated with PBS 1x and calibrated using the GE Healthcare calibration kit The calibration curve of the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erdex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5 HR 30/4 column was prepared according to the instructions of the manufacturer (GE Healthcare). The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v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artition coefficient) values were calculated for 5 proteins of the calibration kits using the equation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v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(Ve-V0)/(Vc-V0), where V0 = column void volume = 7.5 ml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c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geometric column volume = 24 ml and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elution volume for each protein: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vin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bumin (66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9,25 ml, carbonic anhydrase (29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11,55 ml, cytochrome C (12,4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4,09 ml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protinin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6,5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15,05 ml, and  Insulin chain A (2,532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15,65 ml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D)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dY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ld type, CodY-S215A and CodY-S215D were loaded individually and eluted at 0.5 ml min</a:t>
            </a:r>
            <a:r>
              <a:rPr lang="en-US" sz="1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−1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rotein content of the eluate was monitored constantly by measuring absorbance at 280 nm. The experiment was repeated twice with different batches of proteins, and one representative result is shown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indent="-45720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2" name="Groupe 11"/>
          <p:cNvGrpSpPr/>
          <p:nvPr/>
        </p:nvGrpSpPr>
        <p:grpSpPr>
          <a:xfrm>
            <a:off x="173206" y="1299882"/>
            <a:ext cx="6179502" cy="5518150"/>
            <a:chOff x="173206" y="1299882"/>
            <a:chExt cx="6179502" cy="5518150"/>
          </a:xfrm>
        </p:grpSpPr>
        <p:graphicFrame>
          <p:nvGraphicFramePr>
            <p:cNvPr id="3" name="Obje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08284062"/>
                </p:ext>
              </p:extLst>
            </p:nvPr>
          </p:nvGraphicFramePr>
          <p:xfrm>
            <a:off x="866308" y="3477932"/>
            <a:ext cx="5486400" cy="3340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Image bitmap" r:id="rId3" imgW="5486874" imgH="3339901" progId="Paint.Picture">
                    <p:embed/>
                  </p:oleObj>
                </mc:Choice>
                <mc:Fallback>
                  <p:oleObj name="Image bitmap" r:id="rId3" imgW="5486874" imgH="3339901" progId="Paint.Picture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66308" y="3477932"/>
                          <a:ext cx="5486400" cy="3340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95183" y="1591982"/>
              <a:ext cx="3057525" cy="1885950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71632" y="2033652"/>
              <a:ext cx="2370095" cy="1134302"/>
            </a:xfrm>
            <a:prstGeom prst="rect">
              <a:avLst/>
            </a:prstGeom>
          </p:spPr>
        </p:pic>
        <p:sp>
          <p:nvSpPr>
            <p:cNvPr id="7" name="ZoneTexte 6"/>
            <p:cNvSpPr txBox="1"/>
            <p:nvPr/>
          </p:nvSpPr>
          <p:spPr>
            <a:xfrm>
              <a:off x="173206" y="129988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A</a:t>
              </a:r>
              <a:endParaRPr lang="fr-FR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715149" y="1299882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B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73206" y="3691664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707133" y="3691664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D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671632" y="3691664"/>
              <a:ext cx="520674" cy="3877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006920" y="3718542"/>
              <a:ext cx="520674" cy="3877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12744311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520700" y="457200"/>
            <a:ext cx="16834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.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90625" y="1132697"/>
            <a:ext cx="5557265" cy="3308682"/>
            <a:chOff x="218272" y="1222344"/>
            <a:chExt cx="5557265" cy="3308682"/>
          </a:xfrm>
        </p:grpSpPr>
        <p:grpSp>
          <p:nvGrpSpPr>
            <p:cNvPr id="2" name="Groupe 1"/>
            <p:cNvGrpSpPr/>
            <p:nvPr/>
          </p:nvGrpSpPr>
          <p:grpSpPr>
            <a:xfrm>
              <a:off x="1112006" y="1305363"/>
              <a:ext cx="3744416" cy="1499542"/>
              <a:chOff x="1268760" y="1541420"/>
              <a:chExt cx="3744416" cy="1499542"/>
            </a:xfrm>
          </p:grpSpPr>
          <p:pic>
            <p:nvPicPr>
              <p:cNvPr id="3" name="Image 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331809" y="1541420"/>
                <a:ext cx="1265892" cy="728988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1268760" y="1763689"/>
                <a:ext cx="3744416" cy="12772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endParaRPr lang="fr-F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fr-FR" sz="11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B. </a:t>
                </a:r>
                <a:r>
                  <a:rPr lang="fr-FR" sz="11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fr-FR" sz="11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thracis</a:t>
                </a:r>
                <a:r>
                  <a:rPr lang="fr-FR" sz="11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ME motif</a:t>
                </a:r>
              </a:p>
              <a:p>
                <a:endParaRPr lang="fr-F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r>
                  <a:rPr lang="fr-FR" sz="1100" b="1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</a:t>
                </a:r>
                <a:endParaRPr lang="fr-FR" sz="11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endParaRPr lang="fr-FR" sz="110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endParaRPr lang="fr-FR" sz="11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fr-FR" sz="1100" b="1" dirty="0">
                  <a:solidFill>
                    <a:srgbClr val="00407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Groupe 11"/>
            <p:cNvGrpSpPr/>
            <p:nvPr/>
          </p:nvGrpSpPr>
          <p:grpSpPr>
            <a:xfrm>
              <a:off x="218272" y="3566897"/>
              <a:ext cx="5557265" cy="964129"/>
              <a:chOff x="280775" y="1898622"/>
              <a:chExt cx="5564019" cy="923330"/>
            </a:xfrm>
          </p:grpSpPr>
          <p:sp>
            <p:nvSpPr>
              <p:cNvPr id="7" name="Rectangle 6"/>
              <p:cNvSpPr/>
              <p:nvPr/>
            </p:nvSpPr>
            <p:spPr>
              <a:xfrm>
                <a:off x="280775" y="1898622"/>
                <a:ext cx="5564019" cy="92333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0"/>
                  </a:spcAft>
                </a:pPr>
                <a:r>
                  <a:rPr lang="fr-FR" sz="1200" dirty="0" smtClean="0">
                    <a:latin typeface="Bell MT" panose="02020503060305020303" pitchFamily="18" charset="0"/>
                    <a:ea typeface="Times New Roman" panose="02020603050405020304" pitchFamily="18" charset="0"/>
                  </a:rPr>
                  <a:t>GACACGATATATACCAAGGATTACAATTAATCTCGAAATTGATTTTTTTGCATATTTACGTTTAACAATTA</a:t>
                </a:r>
                <a:r>
                  <a:rPr lang="fr-FR" sz="1200" u="sng" dirty="0" smtClean="0">
                    <a:latin typeface="Bell MT" panose="02020503060305020303" pitchFamily="18" charset="0"/>
                    <a:ea typeface="Times New Roman" panose="02020603050405020304" pitchFamily="18" charset="0"/>
                  </a:rPr>
                  <a:t>ACAGAAAAATC</a:t>
                </a:r>
                <a:r>
                  <a:rPr lang="fr-FR" sz="1200" dirty="0" smtClean="0">
                    <a:latin typeface="Bell MT" panose="02020503060305020303" pitchFamily="18" charset="0"/>
                    <a:ea typeface="Times New Roman" panose="02020603050405020304" pitchFamily="18" charset="0"/>
                  </a:rPr>
                  <a:t>AATATAAAAAAATGGGGGTTTCTTAAC</a:t>
                </a:r>
                <a:r>
                  <a:rPr lang="fr-FR" sz="1200" b="1" dirty="0" smtClean="0">
                    <a:latin typeface="Bell MT" panose="02020503060305020303" pitchFamily="18" charset="0"/>
                    <a:ea typeface="Times New Roman" panose="02020603050405020304" pitchFamily="18" charset="0"/>
                  </a:rPr>
                  <a:t>ATGAGAATTAATACAAACATTAACAGCATGCGTACGCAAGAGT</a:t>
                </a:r>
                <a:endParaRPr lang="fr-FR" sz="1200" b="1" dirty="0">
                  <a:latin typeface="Bell MT" panose="02020503060305020303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3765524" y="2250244"/>
                <a:ext cx="594360" cy="24003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1404121" y="2250244"/>
                <a:ext cx="594360" cy="24003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6" name="ZoneTexte 15"/>
            <p:cNvSpPr txBox="1"/>
            <p:nvPr/>
          </p:nvSpPr>
          <p:spPr>
            <a:xfrm>
              <a:off x="252825" y="3278964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fr-FR" sz="1100" i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218272" y="1222344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fr-FR" sz="1100" i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222783" y="2801709"/>
              <a:ext cx="120097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A</a:t>
              </a:r>
              <a:r>
                <a:rPr lang="fr-FR" sz="1100" b="1" dirty="0" smtClean="0">
                  <a:solidFill>
                    <a:srgbClr val="FF0000"/>
                  </a:solidFill>
                  <a:latin typeface="Times" pitchFamily="18" charset="0"/>
                  <a:cs typeface="Times" pitchFamily="18" charset="0"/>
                </a:rPr>
                <a:t>C</a:t>
              </a:r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T</a:t>
              </a:r>
              <a:r>
                <a:rPr lang="fr-FR" sz="1100" b="1" dirty="0" smtClean="0">
                  <a:solidFill>
                    <a:srgbClr val="FF0000"/>
                  </a:solidFill>
                  <a:latin typeface="Times" pitchFamily="18" charset="0"/>
                  <a:cs typeface="Times" pitchFamily="18" charset="0"/>
                </a:rPr>
                <a:t>GAAAA</a:t>
              </a:r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TA</a:t>
              </a:r>
              <a:endParaRPr lang="fr-FR" sz="1100" b="1" dirty="0">
                <a:solidFill>
                  <a:srgbClr val="00B050"/>
                </a:solidFill>
                <a:latin typeface="Times" pitchFamily="18" charset="0"/>
                <a:cs typeface="Times" pitchFamily="18" charset="0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409350" y="2801709"/>
              <a:ext cx="4587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fr-FR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Y</a:t>
              </a:r>
              <a:endParaRPr lang="fr-FR" sz="1200" b="1" i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226791" y="2548389"/>
              <a:ext cx="119295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T</a:t>
              </a:r>
              <a:r>
                <a:rPr lang="fr-FR" sz="1100" b="1" dirty="0" smtClean="0">
                  <a:solidFill>
                    <a:srgbClr val="FF0000"/>
                  </a:solidFill>
                  <a:latin typeface="Times" pitchFamily="18" charset="0"/>
                  <a:cs typeface="Times" pitchFamily="18" charset="0"/>
                </a:rPr>
                <a:t>C</a:t>
              </a:r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T</a:t>
              </a:r>
              <a:r>
                <a:rPr lang="fr-FR" sz="1100" b="1" dirty="0" smtClean="0">
                  <a:solidFill>
                    <a:srgbClr val="FF0000"/>
                  </a:solidFill>
                  <a:latin typeface="Times" pitchFamily="18" charset="0"/>
                  <a:cs typeface="Times" pitchFamily="18" charset="0"/>
                </a:rPr>
                <a:t>GAAAA</a:t>
              </a:r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TA</a:t>
              </a:r>
              <a:endParaRPr lang="fr-FR" sz="1100" b="1" dirty="0">
                <a:solidFill>
                  <a:srgbClr val="00B050"/>
                </a:solidFill>
                <a:latin typeface="Times" pitchFamily="18" charset="0"/>
                <a:cs typeface="Times" pitchFamily="18" charset="0"/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2452632" y="2527906"/>
              <a:ext cx="4154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fr-FR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nI</a:t>
              </a:r>
              <a:endPara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218777" y="2069842"/>
              <a:ext cx="131157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A</a:t>
              </a:r>
              <a:r>
                <a:rPr lang="fr-FR" sz="1100" b="1" dirty="0" smtClean="0">
                  <a:solidFill>
                    <a:srgbClr val="FF0000"/>
                  </a:solidFill>
                  <a:latin typeface="Times" pitchFamily="18" charset="0"/>
                  <a:cs typeface="Times" pitchFamily="18" charset="0"/>
                </a:rPr>
                <a:t>C</a:t>
              </a:r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A</a:t>
              </a:r>
              <a:r>
                <a:rPr lang="fr-FR" sz="1100" b="1" dirty="0" smtClean="0">
                  <a:solidFill>
                    <a:srgbClr val="FF0000"/>
                  </a:solidFill>
                  <a:latin typeface="Times" pitchFamily="18" charset="0"/>
                  <a:cs typeface="Times" pitchFamily="18" charset="0"/>
                </a:rPr>
                <a:t>GAAAA</a:t>
              </a:r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ATC</a:t>
              </a:r>
              <a:endParaRPr lang="fr-FR" sz="1100" b="1" dirty="0">
                <a:solidFill>
                  <a:srgbClr val="00B050"/>
                </a:solidFill>
                <a:latin typeface="Times" pitchFamily="18" charset="0"/>
                <a:cs typeface="Times" pitchFamily="18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2519958" y="2062147"/>
              <a:ext cx="34817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fr-FR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</a:t>
              </a:r>
              <a:endPara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218777" y="2303745"/>
              <a:ext cx="13308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100" b="1" dirty="0" smtClean="0">
                  <a:solidFill>
                    <a:srgbClr val="00B050"/>
                  </a:solidFill>
                  <a:latin typeface="Times" pitchFamily="18" charset="0"/>
                  <a:cs typeface="Times" pitchFamily="18" charset="0"/>
                </a:rPr>
                <a:t>CGC</a:t>
              </a:r>
              <a:r>
                <a:rPr lang="fr-FR" sz="1100" b="1" dirty="0" smtClean="0">
                  <a:solidFill>
                    <a:srgbClr val="FF0000"/>
                  </a:solidFill>
                  <a:latin typeface="Times" pitchFamily="18" charset="0"/>
                  <a:cs typeface="Times" pitchFamily="18" charset="0"/>
                </a:rPr>
                <a:t>TGGAAAGC</a:t>
              </a:r>
              <a:endParaRPr lang="fr-FR" sz="1100" b="1" dirty="0">
                <a:solidFill>
                  <a:srgbClr val="00B050"/>
                </a:solidFill>
                <a:latin typeface="Times" pitchFamily="18" charset="0"/>
                <a:cs typeface="Times" pitchFamily="18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2443014" y="2289624"/>
              <a:ext cx="4251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fr-FR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*</a:t>
              </a:r>
              <a:endPara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" name="Rectangle 24"/>
          <p:cNvSpPr/>
          <p:nvPr/>
        </p:nvSpPr>
        <p:spPr>
          <a:xfrm>
            <a:off x="400594" y="4763913"/>
            <a:ext cx="6537325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dirty="0" smtClean="0"/>
              <a:t>Fig. S2. Promoter region of the </a:t>
            </a:r>
            <a:r>
              <a:rPr lang="en-US" sz="1100" i="1" dirty="0" err="1" smtClean="0"/>
              <a:t>fla</a:t>
            </a:r>
            <a:r>
              <a:rPr lang="en-US" sz="1100" dirty="0" smtClean="0"/>
              <a:t> operon. (A) Comparison </a:t>
            </a:r>
            <a:r>
              <a:rPr lang="en-US" sz="1100" dirty="0"/>
              <a:t>of </a:t>
            </a:r>
            <a:r>
              <a:rPr lang="en-US" sz="1100" dirty="0" smtClean="0"/>
              <a:t>the putative </a:t>
            </a:r>
            <a:r>
              <a:rPr lang="en-US" sz="1100" dirty="0" err="1" smtClean="0"/>
              <a:t>CodY</a:t>
            </a:r>
            <a:r>
              <a:rPr lang="en-US" sz="1100" dirty="0" smtClean="0"/>
              <a:t> box of the </a:t>
            </a:r>
            <a:r>
              <a:rPr lang="en-US" sz="1100" i="1" dirty="0" err="1" smtClean="0"/>
              <a:t>fla</a:t>
            </a:r>
            <a:r>
              <a:rPr lang="en-US" sz="1100" dirty="0" smtClean="0"/>
              <a:t> operon with the consensus </a:t>
            </a:r>
            <a:r>
              <a:rPr lang="en-US" sz="1100" i="1" dirty="0" smtClean="0"/>
              <a:t>B. </a:t>
            </a:r>
            <a:r>
              <a:rPr lang="en-US" sz="1100" i="1" dirty="0" err="1" smtClean="0"/>
              <a:t>anthracis</a:t>
            </a:r>
            <a:r>
              <a:rPr lang="en-US" sz="1100" i="1" dirty="0" smtClean="0"/>
              <a:t> </a:t>
            </a:r>
            <a:r>
              <a:rPr lang="en-US" sz="1100" dirty="0" err="1" smtClean="0"/>
              <a:t>CodY</a:t>
            </a:r>
            <a:r>
              <a:rPr lang="en-US" sz="1100" dirty="0" smtClean="0"/>
              <a:t> box (</a:t>
            </a:r>
            <a:r>
              <a:rPr lang="en-US" sz="1100" dirty="0"/>
              <a:t>B</a:t>
            </a:r>
            <a:r>
              <a:rPr lang="en-US" sz="1100" dirty="0" smtClean="0"/>
              <a:t>) Putative </a:t>
            </a:r>
            <a:r>
              <a:rPr lang="en-US" sz="1100" dirty="0" err="1" smtClean="0">
                <a:latin typeface="Symbol" panose="05050102010706020507" pitchFamily="18" charset="2"/>
              </a:rPr>
              <a:t>s</a:t>
            </a:r>
            <a:r>
              <a:rPr lang="en-US" sz="1100" dirty="0" err="1" smtClean="0"/>
              <a:t>A</a:t>
            </a:r>
            <a:r>
              <a:rPr lang="en-US" sz="1100" dirty="0" smtClean="0"/>
              <a:t> promoter sequence of the </a:t>
            </a:r>
            <a:r>
              <a:rPr lang="en-US" sz="1100" i="1" dirty="0" err="1" smtClean="0"/>
              <a:t>fla</a:t>
            </a:r>
            <a:r>
              <a:rPr lang="en-US" sz="1100" i="1" dirty="0" smtClean="0"/>
              <a:t> </a:t>
            </a:r>
            <a:r>
              <a:rPr lang="en-US" sz="1100" dirty="0" smtClean="0"/>
              <a:t>operon. The sequence  corresponds to the 151 </a:t>
            </a:r>
            <a:r>
              <a:rPr lang="en-US" sz="1100" dirty="0" err="1" smtClean="0"/>
              <a:t>bp</a:t>
            </a:r>
            <a:r>
              <a:rPr lang="en-US" sz="1100" dirty="0" smtClean="0"/>
              <a:t> fragment used in gel retardation experiments. Boxes surround the putative -35 </a:t>
            </a:r>
            <a:r>
              <a:rPr lang="en-US" sz="1100" dirty="0"/>
              <a:t>and </a:t>
            </a:r>
            <a:r>
              <a:rPr lang="en-US" sz="1100" dirty="0" smtClean="0"/>
              <a:t>-10 boxes (left and right</a:t>
            </a:r>
            <a:r>
              <a:rPr lang="en-US" sz="1100" dirty="0"/>
              <a:t>, respectively</a:t>
            </a:r>
            <a:r>
              <a:rPr lang="en-US" sz="1100" dirty="0" smtClean="0"/>
              <a:t>). The </a:t>
            </a:r>
            <a:r>
              <a:rPr lang="en-US" sz="1100" dirty="0" err="1" smtClean="0"/>
              <a:t>CodY</a:t>
            </a:r>
            <a:r>
              <a:rPr lang="en-US" sz="1100" dirty="0" smtClean="0"/>
              <a:t> box is underlined. </a:t>
            </a:r>
            <a:r>
              <a:rPr lang="en-US" sz="1100" dirty="0"/>
              <a:t>The </a:t>
            </a:r>
            <a:r>
              <a:rPr lang="en-US" sz="1100" dirty="0" smtClean="0"/>
              <a:t>beginning of the BC1659 coding sequence is </a:t>
            </a:r>
            <a:r>
              <a:rPr lang="en-US" sz="1100" dirty="0"/>
              <a:t>highlighted in </a:t>
            </a:r>
            <a:r>
              <a:rPr lang="en-US" sz="1100" dirty="0" smtClean="0"/>
              <a:t>bold. </a:t>
            </a:r>
            <a:endParaRPr lang="en-US" sz="1100" dirty="0"/>
          </a:p>
          <a:p>
            <a:pPr algn="just"/>
            <a:endParaRPr lang="en-US" sz="1100" dirty="0" smtClean="0"/>
          </a:p>
        </p:txBody>
      </p:sp>
    </p:spTree>
    <p:extLst>
      <p:ext uri="{BB962C8B-B14F-4D97-AF65-F5344CB8AC3E}">
        <p14:creationId xmlns:p14="http://schemas.microsoft.com/office/powerpoint/2010/main" val="3430573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1249642" y="2662319"/>
            <a:ext cx="4321243" cy="1469596"/>
            <a:chOff x="861022" y="764939"/>
            <a:chExt cx="4321243" cy="1469596"/>
          </a:xfrm>
        </p:grpSpPr>
        <p:sp>
          <p:nvSpPr>
            <p:cNvPr id="5" name="ZoneTexte 4"/>
            <p:cNvSpPr txBox="1"/>
            <p:nvPr/>
          </p:nvSpPr>
          <p:spPr>
            <a:xfrm>
              <a:off x="1427131" y="1035333"/>
              <a:ext cx="4067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1806623" y="1035333"/>
              <a:ext cx="3145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0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049125" y="1031885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2390097" y="1031195"/>
              <a:ext cx="4067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769589" y="1031195"/>
              <a:ext cx="3145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0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3012091" y="1027747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321823" y="1037003"/>
              <a:ext cx="4067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3645024" y="1037003"/>
              <a:ext cx="3145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0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3861048" y="1033555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160803" y="1035333"/>
              <a:ext cx="4067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540295" y="1035333"/>
              <a:ext cx="3145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0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782797" y="1031885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1748317" y="764939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2707867" y="766609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dY</a:t>
              </a:r>
              <a:endPara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3512731" y="766609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15A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4360560" y="766609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15D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Connecteur droit avec flèche 20"/>
            <p:cNvCxnSpPr/>
            <p:nvPr/>
          </p:nvCxnSpPr>
          <p:spPr>
            <a:xfrm>
              <a:off x="1319502" y="1830180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ZoneTexte 21"/>
            <p:cNvSpPr txBox="1"/>
            <p:nvPr/>
          </p:nvSpPr>
          <p:spPr>
            <a:xfrm>
              <a:off x="861022" y="1691680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dY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Connecteur droit 22"/>
            <p:cNvCxnSpPr/>
            <p:nvPr/>
          </p:nvCxnSpPr>
          <p:spPr>
            <a:xfrm>
              <a:off x="4273490" y="1043608"/>
              <a:ext cx="8116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23"/>
            <p:cNvCxnSpPr/>
            <p:nvPr/>
          </p:nvCxnSpPr>
          <p:spPr>
            <a:xfrm>
              <a:off x="3409394" y="1043608"/>
              <a:ext cx="8116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24"/>
            <p:cNvCxnSpPr/>
            <p:nvPr/>
          </p:nvCxnSpPr>
          <p:spPr>
            <a:xfrm>
              <a:off x="2492896" y="1043608"/>
              <a:ext cx="8116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25"/>
            <p:cNvCxnSpPr/>
            <p:nvPr/>
          </p:nvCxnSpPr>
          <p:spPr>
            <a:xfrm>
              <a:off x="1556792" y="1043608"/>
              <a:ext cx="8116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7" name="Image 2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69571" y="1329660"/>
              <a:ext cx="3695700" cy="904875"/>
            </a:xfrm>
            <a:prstGeom prst="rect">
              <a:avLst/>
            </a:prstGeom>
          </p:spPr>
        </p:pic>
      </p:grpSp>
      <p:sp>
        <p:nvSpPr>
          <p:cNvPr id="28" name="ZoneTexte 27"/>
          <p:cNvSpPr txBox="1"/>
          <p:nvPr/>
        </p:nvSpPr>
        <p:spPr>
          <a:xfrm>
            <a:off x="622300" y="977900"/>
            <a:ext cx="16834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.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145822" y="4629131"/>
            <a:ext cx="709477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stern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t Crude extracts were prepared from bacteria grown in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B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um. Aliquots were taken at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d exponential phase, t0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nd of exponential phas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2 hours after t0, as calculated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growth curve based on OD600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s (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0 and stat, respectively). 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13941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59</TotalTime>
  <Words>574</Words>
  <Application>Microsoft Office PowerPoint</Application>
  <PresentationFormat>Personnalisé</PresentationFormat>
  <Paragraphs>127</Paragraphs>
  <Slides>4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7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3" baseType="lpstr">
      <vt:lpstr>Arial</vt:lpstr>
      <vt:lpstr>Bell MT</vt:lpstr>
      <vt:lpstr>Calibri</vt:lpstr>
      <vt:lpstr>Calibri Light</vt:lpstr>
      <vt:lpstr>Symbol</vt:lpstr>
      <vt:lpstr>Times</vt:lpstr>
      <vt:lpstr>Times New Roman</vt:lpstr>
      <vt:lpstr>Thème Office</vt:lpstr>
      <vt:lpstr>Image bitmap</vt:lpstr>
      <vt:lpstr>Présentation PowerPoint</vt:lpstr>
      <vt:lpstr>Présentation PowerPoint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ndrine Poncet-Mouturat</dc:creator>
  <cp:lastModifiedBy>Sandrine Poncet-Mouturat</cp:lastModifiedBy>
  <cp:revision>127</cp:revision>
  <cp:lastPrinted>2021-09-30T09:37:28Z</cp:lastPrinted>
  <dcterms:created xsi:type="dcterms:W3CDTF">2018-05-14T12:03:58Z</dcterms:created>
  <dcterms:modified xsi:type="dcterms:W3CDTF">2025-09-11T15:14:48Z</dcterms:modified>
</cp:coreProperties>
</file>